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53" d="100"/>
          <a:sy n="53" d="100"/>
        </p:scale>
        <p:origin x="2268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561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557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3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722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008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5483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6739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0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662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2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0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944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683568"/>
            <a:ext cx="1938337" cy="2116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66946" y="2741603"/>
            <a:ext cx="551032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area under the curve (AUC) of oral glucose tolerance test (OGTT) of INT diet group significantly lower than the C and MF diet groups, but not to the extent of CR diet group.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571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4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li, Fenni</dc:creator>
  <cp:lastModifiedBy>Fenni Rusli</cp:lastModifiedBy>
  <cp:revision>9</cp:revision>
  <dcterms:created xsi:type="dcterms:W3CDTF">2013-12-19T15:51:17Z</dcterms:created>
  <dcterms:modified xsi:type="dcterms:W3CDTF">2014-11-17T00:29:14Z</dcterms:modified>
</cp:coreProperties>
</file>